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87" r:id="rId2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1DEE231-F65B-8F99-7EF4-8F60D3ABAD45}" name="Radka Vozárová" initials="RV" userId="S::vozarova@ibpcz.onmicrosoft.com::10c7d2bb-9bf3-4821-8bce-ea4c90b92261" providerId="AD"/>
  <p188:author id="{94518BCE-C8DB-2C8B-4E15-DB5CED368DA5}" name="Jana Lunerová" initials="JL" userId="S::jana.luner@ibpcz.onmicrosoft.com::1ab8f279-02ea-4500-b1ed-a8eb64d2bf92" providerId="AD"/>
  <p188:author id="{79240FDB-A574-7C02-B575-3AE43C89DDE3}" name="Jana Lunerová" initials="JL" userId="Jana Lunerová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484" autoAdjust="0"/>
  </p:normalViewPr>
  <p:slideViewPr>
    <p:cSldViewPr snapToGrid="0">
      <p:cViewPr varScale="1">
        <p:scale>
          <a:sx n="101" d="100"/>
          <a:sy n="101" d="100"/>
        </p:scale>
        <p:origin x="95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BA6860-6347-4252-9D99-E3D3FE4643F7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8AB7C7-A152-49A0-9654-7A02B150DC2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45763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49039CC-89C9-45CD-9B19-095FFCB4C7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52FA946B-59DC-4D0D-9019-11FA9BF2EC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AC9F1B01-997A-4EAB-8C74-E997AB84F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9D5993D0-DDC2-436B-B011-C467D9AB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57B0017-0284-4947-AFC5-3B8FF1815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39735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492208B-13C3-4453-AE08-7769C8B3D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00FB78A7-C118-44E5-B2BE-C845752EE5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4D51294-C6F0-45B1-8D5A-9F2165612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E0B8CBE-FB11-4DD5-8F65-D8B1CC71E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DE7B16B-E6C1-4CAE-9528-5D68A5D65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2519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1728F8F3-C5DC-4F33-A4A2-497C3CAEB0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D1E2B75A-0FE5-4A9F-A8F2-EF6CC2D45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1F8855EA-5644-4E71-B656-72250C98E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0E4D3B26-FE5D-4C2A-838D-ED9F263DD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A787EB7-28ED-4EF2-AAA6-809CA43C1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46300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A053A50-F42E-469C-A4DC-BB6C1159A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993A34E6-07ED-44F0-85D6-71C1D838D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9099696C-446D-4500-8B26-FF027363D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3FB5056-D79E-4571-AE61-498BB8B45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8A45115-DFD7-4B36-86AF-A120A91B0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627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5D96BD8-307D-45DD-8E45-165B7D9AF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054C7D9C-970D-4766-A87D-777DE950B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B70794D-2632-4E1B-8901-38C970CFD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116A6357-1F34-45CB-B403-A734CB9D4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91D0CD83-3D69-4AEB-B78C-C54E37275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80791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A0501AF-A84D-42EF-8493-0323C1D6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C542208A-477D-49CC-918C-442E4CDBE5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33859FAA-BD81-44CD-B855-35A553E627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A4845196-3870-4EB0-B503-7E9D7C97B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7A8083E4-881B-4E72-BFAC-CC3266E79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075926A8-FD85-4894-8B19-3DF72271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2604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3EFD6A1-62AE-40E1-ADDD-216B10DCB8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14144B3-12FC-4B30-9C86-04C0E043A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131B6B39-A08C-4661-9009-AD7CFBB48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B609063B-0776-41BD-A429-CF79C0CB29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A5E447EA-76FC-4D0C-9A88-B300584511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DF94230D-6436-419A-892E-A73F139FB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D58F1ADE-6F21-4749-8CCF-FD935784D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3F484B44-4739-4F7C-B351-24161B3BA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85798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D92114E-D6A1-4F66-AB6A-5B8F95DB2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1B6DE6C3-DBC0-4087-A08F-851D1A198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52496DC8-E66D-4BEB-AF1E-7CDF334F0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DFD09EEA-973C-4392-AF59-92A0C0847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79567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8D9AF19E-D4E0-4D83-AD00-D0DFB405E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72D447CD-18DA-4A2C-B77D-8CAEFEE91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F5D47266-9485-4357-B858-446D5D489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88915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9D2B7B6-1C19-441D-97A7-74D102C51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60C4C94-44C5-4C73-954E-E8C6DD0289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6EA008ED-5FC5-4516-80E3-1CA4A5183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2F6C7ABB-5449-4ABD-845D-8F9D01EBD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D9E9EC48-6FB3-4460-9585-7BFA35CD6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552FE676-7FE8-4215-AF5C-E81E11489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72845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7948D46-7216-4856-A3F7-B35ACC90D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9A7130B0-B409-4726-BBCE-2602465782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BEBC048F-FC7F-48CE-B771-E867FB3F4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577E07ED-60F2-478D-82CC-2BD1DF8A4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3649A336-6239-4A5C-89F9-2E6A1E196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BD34E1B6-3095-4794-8320-AB486EE01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34316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EC7869CA-580F-48C5-9F96-03C7FD85B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4C0EFDB0-0EB9-42FD-BE31-433B80F8D4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20FA9E4A-544F-4E58-A161-6AB1428324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51AB8EF-3D04-4F91-A146-BB50B545D1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9EA0394-177C-486B-A4BB-3400A50B3D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70168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TIF"/><Relationship Id="rId7" Type="http://schemas.openxmlformats.org/officeDocument/2006/relationships/image" Target="../media/image6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Skupina 3">
            <a:extLst>
              <a:ext uri="{FF2B5EF4-FFF2-40B4-BE49-F238E27FC236}">
                <a16:creationId xmlns:a16="http://schemas.microsoft.com/office/drawing/2014/main" id="{E6107BF3-260C-1956-1A43-761605A4F9DE}"/>
              </a:ext>
            </a:extLst>
          </p:cNvPr>
          <p:cNvGrpSpPr/>
          <p:nvPr/>
        </p:nvGrpSpPr>
        <p:grpSpPr>
          <a:xfrm>
            <a:off x="1439876" y="1060195"/>
            <a:ext cx="8318759" cy="5685895"/>
            <a:chOff x="293615" y="949797"/>
            <a:chExt cx="8318759" cy="5685895"/>
          </a:xfrm>
        </p:grpSpPr>
        <p:pic>
          <p:nvPicPr>
            <p:cNvPr id="5" name="Obrázek 4" descr="Obsah obrázku displej, noční obloha&#10;&#10;Popis byl vytvořen automaticky">
              <a:extLst>
                <a:ext uri="{FF2B5EF4-FFF2-40B4-BE49-F238E27FC236}">
                  <a16:creationId xmlns:a16="http://schemas.microsoft.com/office/drawing/2014/main" id="{B784ACD6-E2BD-C00E-11F6-ACE707BFD8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18" t="16056" r="31643" b="36238"/>
            <a:stretch/>
          </p:blipFill>
          <p:spPr>
            <a:xfrm>
              <a:off x="3302112" y="949797"/>
              <a:ext cx="2606742" cy="2430967"/>
            </a:xfrm>
            <a:prstGeom prst="rect">
              <a:avLst/>
            </a:prstGeom>
          </p:spPr>
        </p:pic>
        <p:pic>
          <p:nvPicPr>
            <p:cNvPr id="9" name="Obrázek 8" descr="Obsah obrázku laserová&#10;&#10;Popis byl vytvořen automaticky">
              <a:extLst>
                <a:ext uri="{FF2B5EF4-FFF2-40B4-BE49-F238E27FC236}">
                  <a16:creationId xmlns:a16="http://schemas.microsoft.com/office/drawing/2014/main" id="{78CA39BA-939B-BB06-4C4F-239890726B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75" t="15850" r="30818" b="36776"/>
            <a:stretch/>
          </p:blipFill>
          <p:spPr>
            <a:xfrm>
              <a:off x="5901639" y="956881"/>
              <a:ext cx="2710735" cy="2423883"/>
            </a:xfrm>
            <a:prstGeom prst="rect">
              <a:avLst/>
            </a:prstGeom>
          </p:spPr>
        </p:pic>
        <p:pic>
          <p:nvPicPr>
            <p:cNvPr id="13" name="Obrázek 12" descr="Obsah obrázku noční obloha&#10;&#10;Popis byl vytvořen automaticky">
              <a:extLst>
                <a:ext uri="{FF2B5EF4-FFF2-40B4-BE49-F238E27FC236}">
                  <a16:creationId xmlns:a16="http://schemas.microsoft.com/office/drawing/2014/main" id="{BBB51D4B-899C-0B36-9FE8-9464B7A63D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90" t="34618" r="18934" b="30275"/>
            <a:stretch/>
          </p:blipFill>
          <p:spPr>
            <a:xfrm>
              <a:off x="3252952" y="3998509"/>
              <a:ext cx="2606708" cy="2637183"/>
            </a:xfrm>
            <a:prstGeom prst="rect">
              <a:avLst/>
            </a:prstGeom>
          </p:spPr>
        </p:pic>
        <p:pic>
          <p:nvPicPr>
            <p:cNvPr id="3" name="Obrázek 2" descr="Obsah obrázku polévka&#10;&#10;Popis byl vytvořen automaticky">
              <a:extLst>
                <a:ext uri="{FF2B5EF4-FFF2-40B4-BE49-F238E27FC236}">
                  <a16:creationId xmlns:a16="http://schemas.microsoft.com/office/drawing/2014/main" id="{558818BB-F519-5705-C873-71B4BF9603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120" t="28333" r="16681" b="30933"/>
            <a:stretch/>
          </p:blipFill>
          <p:spPr>
            <a:xfrm>
              <a:off x="293615" y="3663214"/>
              <a:ext cx="2879519" cy="2888192"/>
            </a:xfrm>
            <a:prstGeom prst="rect">
              <a:avLst/>
            </a:prstGeom>
          </p:spPr>
        </p:pic>
        <p:pic>
          <p:nvPicPr>
            <p:cNvPr id="6" name="Obrázek 5" descr="Obsah obrázku noční obloha&#10;&#10;Popis byl vytvořen automaticky">
              <a:extLst>
                <a:ext uri="{FF2B5EF4-FFF2-40B4-BE49-F238E27FC236}">
                  <a16:creationId xmlns:a16="http://schemas.microsoft.com/office/drawing/2014/main" id="{C8378173-0FD5-0802-E66A-00D5F6F8C6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t="32998" r="18778" b="31665"/>
            <a:stretch/>
          </p:blipFill>
          <p:spPr>
            <a:xfrm>
              <a:off x="5852478" y="3998508"/>
              <a:ext cx="2710735" cy="2637184"/>
            </a:xfrm>
            <a:prstGeom prst="rect">
              <a:avLst/>
            </a:prstGeom>
          </p:spPr>
        </p:pic>
        <p:sp>
          <p:nvSpPr>
            <p:cNvPr id="8" name="TextovéPole 7">
              <a:extLst>
                <a:ext uri="{FF2B5EF4-FFF2-40B4-BE49-F238E27FC236}">
                  <a16:creationId xmlns:a16="http://schemas.microsoft.com/office/drawing/2014/main" id="{6D106D87-A88C-7AF0-CDBA-7B7199FB36C6}"/>
                </a:ext>
              </a:extLst>
            </p:cNvPr>
            <p:cNvSpPr txBox="1"/>
            <p:nvPr/>
          </p:nvSpPr>
          <p:spPr>
            <a:xfrm>
              <a:off x="1920836" y="3908655"/>
              <a:ext cx="132824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600" dirty="0" err="1"/>
                <a:t>Inverted</a:t>
              </a:r>
              <a:r>
                <a:rPr lang="cs-CZ" sz="1600" dirty="0"/>
                <a:t> DAPI</a:t>
              </a:r>
            </a:p>
          </p:txBody>
        </p:sp>
      </p:grpSp>
      <p:sp>
        <p:nvSpPr>
          <p:cNvPr id="2" name="TextovéPole 1">
            <a:extLst>
              <a:ext uri="{FF2B5EF4-FFF2-40B4-BE49-F238E27FC236}">
                <a16:creationId xmlns:a16="http://schemas.microsoft.com/office/drawing/2014/main" id="{5F63676A-591F-698E-1CA0-1133B74593FE}"/>
              </a:ext>
            </a:extLst>
          </p:cNvPr>
          <p:cNvSpPr txBox="1"/>
          <p:nvPr/>
        </p:nvSpPr>
        <p:spPr>
          <a:xfrm>
            <a:off x="150528" y="66394"/>
            <a:ext cx="119271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S</a:t>
            </a:r>
            <a:r>
              <a:rPr lang="cs-CZ" sz="1600" b="1" dirty="0"/>
              <a:t>3</a:t>
            </a:r>
            <a:r>
              <a:rPr lang="en-US" sz="1600" b="1" dirty="0"/>
              <a:t>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mmunolocalization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3S10p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ark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osa </a:t>
            </a:r>
            <a:r>
              <a:rPr lang="cs-CZ" sz="1600" i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itida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(2n=2x=14), a species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rmal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iosi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cs-CZ" sz="1600" dirty="0" err="1"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iotic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hromosome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akinesi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7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ivalents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t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ven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mmunostaining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ver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ntir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chromosome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ength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ot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tip metaphase.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t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H3S10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hosphorylation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itotic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hromosome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estrict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to (peri)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entromeric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egion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ar 10 µm.</a:t>
            </a:r>
            <a:endParaRPr lang="cs-CZ" sz="1600" dirty="0">
              <a:highlight>
                <a:srgbClr val="FFFF00"/>
              </a:highlight>
            </a:endParaRPr>
          </a:p>
        </p:txBody>
      </p:sp>
      <p:sp>
        <p:nvSpPr>
          <p:cNvPr id="10" name="TextovéPole 9">
            <a:extLst>
              <a:ext uri="{FF2B5EF4-FFF2-40B4-BE49-F238E27FC236}">
                <a16:creationId xmlns:a16="http://schemas.microsoft.com/office/drawing/2014/main" id="{83CA4582-A7C3-223D-20BE-D51CB1F4F06B}"/>
              </a:ext>
            </a:extLst>
          </p:cNvPr>
          <p:cNvSpPr txBox="1"/>
          <p:nvPr/>
        </p:nvSpPr>
        <p:spPr>
          <a:xfrm>
            <a:off x="1177831" y="1032986"/>
            <a:ext cx="317716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A</a:t>
            </a:r>
            <a:endParaRPr lang="en-US" dirty="0"/>
          </a:p>
          <a:p>
            <a:endParaRPr lang="en-US" sz="2400" dirty="0"/>
          </a:p>
        </p:txBody>
      </p:sp>
      <p:pic>
        <p:nvPicPr>
          <p:cNvPr id="14" name="Obrázek 13">
            <a:extLst>
              <a:ext uri="{FF2B5EF4-FFF2-40B4-BE49-F238E27FC236}">
                <a16:creationId xmlns:a16="http://schemas.microsoft.com/office/drawing/2014/main" id="{198E912E-CFA1-8D9B-75FF-36FC96116EF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35451" t="31793" r="40787" b="42818"/>
          <a:stretch/>
        </p:blipFill>
        <p:spPr>
          <a:xfrm>
            <a:off x="1839014" y="1077111"/>
            <a:ext cx="2606742" cy="2414051"/>
          </a:xfrm>
          <a:prstGeom prst="rect">
            <a:avLst/>
          </a:prstGeom>
        </p:spPr>
      </p:pic>
      <p:sp>
        <p:nvSpPr>
          <p:cNvPr id="19" name="TextovéPole 18">
            <a:extLst>
              <a:ext uri="{FF2B5EF4-FFF2-40B4-BE49-F238E27FC236}">
                <a16:creationId xmlns:a16="http://schemas.microsoft.com/office/drawing/2014/main" id="{63C72107-1B46-C6F2-EFE9-182466BA88EC}"/>
              </a:ext>
            </a:extLst>
          </p:cNvPr>
          <p:cNvSpPr txBox="1"/>
          <p:nvPr/>
        </p:nvSpPr>
        <p:spPr>
          <a:xfrm>
            <a:off x="3841563" y="1017768"/>
            <a:ext cx="6333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20" name="TextovéPole 19">
            <a:extLst>
              <a:ext uri="{FF2B5EF4-FFF2-40B4-BE49-F238E27FC236}">
                <a16:creationId xmlns:a16="http://schemas.microsoft.com/office/drawing/2014/main" id="{6AB784E6-51C2-CFAD-F749-A47CD145F076}"/>
              </a:ext>
            </a:extLst>
          </p:cNvPr>
          <p:cNvSpPr txBox="1"/>
          <p:nvPr/>
        </p:nvSpPr>
        <p:spPr>
          <a:xfrm>
            <a:off x="6207494" y="993052"/>
            <a:ext cx="905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 err="1">
                <a:solidFill>
                  <a:schemeClr val="bg1"/>
                </a:solidFill>
              </a:rPr>
              <a:t>merged</a:t>
            </a:r>
            <a:endParaRPr lang="cs-CZ" dirty="0">
              <a:solidFill>
                <a:schemeClr val="bg1"/>
              </a:solidFill>
            </a:endParaRPr>
          </a:p>
        </p:txBody>
      </p:sp>
      <p:sp>
        <p:nvSpPr>
          <p:cNvPr id="21" name="TextovéPole 20">
            <a:extLst>
              <a:ext uri="{FF2B5EF4-FFF2-40B4-BE49-F238E27FC236}">
                <a16:creationId xmlns:a16="http://schemas.microsoft.com/office/drawing/2014/main" id="{069F72AD-C6EF-53B5-1CFB-E731E28D565F}"/>
              </a:ext>
            </a:extLst>
          </p:cNvPr>
          <p:cNvSpPr txBox="1"/>
          <p:nvPr/>
        </p:nvSpPr>
        <p:spPr>
          <a:xfrm>
            <a:off x="8902773" y="993764"/>
            <a:ext cx="905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>
                <a:solidFill>
                  <a:schemeClr val="bg1"/>
                </a:solidFill>
              </a:rPr>
              <a:t>H3S10P</a:t>
            </a:r>
          </a:p>
        </p:txBody>
      </p:sp>
      <p:sp>
        <p:nvSpPr>
          <p:cNvPr id="22" name="TextovéPole 21">
            <a:extLst>
              <a:ext uri="{FF2B5EF4-FFF2-40B4-BE49-F238E27FC236}">
                <a16:creationId xmlns:a16="http://schemas.microsoft.com/office/drawing/2014/main" id="{F0679C28-E8B4-4CE7-B098-519776D41D87}"/>
              </a:ext>
            </a:extLst>
          </p:cNvPr>
          <p:cNvSpPr txBox="1"/>
          <p:nvPr/>
        </p:nvSpPr>
        <p:spPr>
          <a:xfrm>
            <a:off x="8895908" y="4064536"/>
            <a:ext cx="905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>
                <a:solidFill>
                  <a:schemeClr val="bg1"/>
                </a:solidFill>
              </a:rPr>
              <a:t>H3S10P</a:t>
            </a:r>
          </a:p>
        </p:txBody>
      </p:sp>
      <p:sp>
        <p:nvSpPr>
          <p:cNvPr id="23" name="TextovéPole 22">
            <a:extLst>
              <a:ext uri="{FF2B5EF4-FFF2-40B4-BE49-F238E27FC236}">
                <a16:creationId xmlns:a16="http://schemas.microsoft.com/office/drawing/2014/main" id="{D942B61F-DD63-5C9D-ADB3-C65791D1A567}"/>
              </a:ext>
            </a:extLst>
          </p:cNvPr>
          <p:cNvSpPr txBox="1"/>
          <p:nvPr/>
        </p:nvSpPr>
        <p:spPr>
          <a:xfrm>
            <a:off x="6248245" y="4055862"/>
            <a:ext cx="905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 err="1">
                <a:solidFill>
                  <a:schemeClr val="bg1"/>
                </a:solidFill>
              </a:rPr>
              <a:t>merged</a:t>
            </a:r>
            <a:endParaRPr lang="cs-CZ" dirty="0">
              <a:solidFill>
                <a:schemeClr val="bg1"/>
              </a:solidFill>
            </a:endParaRPr>
          </a:p>
        </p:txBody>
      </p:sp>
      <p:cxnSp>
        <p:nvCxnSpPr>
          <p:cNvPr id="7" name="Přímá spojnice 6">
            <a:extLst>
              <a:ext uri="{FF2B5EF4-FFF2-40B4-BE49-F238E27FC236}">
                <a16:creationId xmlns:a16="http://schemas.microsoft.com/office/drawing/2014/main" id="{FFF1A0D4-25BF-0D38-A5B2-68B084E14010}"/>
              </a:ext>
            </a:extLst>
          </p:cNvPr>
          <p:cNvCxnSpPr>
            <a:cxnSpLocks/>
          </p:cNvCxnSpPr>
          <p:nvPr/>
        </p:nvCxnSpPr>
        <p:spPr>
          <a:xfrm>
            <a:off x="3632062" y="3357059"/>
            <a:ext cx="687333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Přímá spojnice 11">
            <a:extLst>
              <a:ext uri="{FF2B5EF4-FFF2-40B4-BE49-F238E27FC236}">
                <a16:creationId xmlns:a16="http://schemas.microsoft.com/office/drawing/2014/main" id="{1C5052AC-1D1E-9918-B9BC-A6D945CF57F0}"/>
              </a:ext>
            </a:extLst>
          </p:cNvPr>
          <p:cNvCxnSpPr/>
          <p:nvPr/>
        </p:nvCxnSpPr>
        <p:spPr>
          <a:xfrm>
            <a:off x="3095625" y="6590231"/>
            <a:ext cx="876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ovéPole 10">
            <a:extLst>
              <a:ext uri="{FF2B5EF4-FFF2-40B4-BE49-F238E27FC236}">
                <a16:creationId xmlns:a16="http://schemas.microsoft.com/office/drawing/2014/main" id="{81EB71E3-850C-F017-E9D2-D942C2F5CD48}"/>
              </a:ext>
            </a:extLst>
          </p:cNvPr>
          <p:cNvSpPr txBox="1"/>
          <p:nvPr/>
        </p:nvSpPr>
        <p:spPr>
          <a:xfrm>
            <a:off x="1242334" y="387119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05910519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82</TotalTime>
  <Words>84</Words>
  <Application>Microsoft Office PowerPoint</Application>
  <PresentationFormat>Širokoúhlá obrazovka</PresentationFormat>
  <Paragraphs>9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NEROVÁ Aneta</dc:creator>
  <cp:lastModifiedBy>Jana Luner</cp:lastModifiedBy>
  <cp:revision>711</cp:revision>
  <dcterms:created xsi:type="dcterms:W3CDTF">2022-01-03T14:46:27Z</dcterms:created>
  <dcterms:modified xsi:type="dcterms:W3CDTF">2023-10-10T11:22:11Z</dcterms:modified>
</cp:coreProperties>
</file>